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504031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739AA-B3CE-4C6E-9BAA-AC60694238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48607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0000" y="2913840"/>
            <a:ext cx="48607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8E4E4-52ED-45E8-A403-AB548B7F4D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76048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0000" y="291384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760480" y="291384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9B7B8-A8D7-4626-A627-BD6A1D1105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13400" y="117648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557160" y="117648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0000" y="291384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13400" y="291384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557160" y="2913840"/>
            <a:ext cx="15649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DF64F-D209-4523-8896-D4A789DC8A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0000" y="1176480"/>
            <a:ext cx="4860720" cy="33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81967-B03E-4FEC-B0A0-C1307AFDAC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486072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96161-FF12-4E37-806C-50C491F8BB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23716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760480" y="1176480"/>
            <a:ext cx="23716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DE000-5752-40F6-B1CD-90577263DA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FCC24-F971-47A1-A3F4-2272E04C94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0000" y="201240"/>
            <a:ext cx="4860720" cy="389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8DE29-966A-45FC-B788-3AD8FB580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760480" y="1176480"/>
            <a:ext cx="23716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0000" y="291384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AEACC-7717-422E-9F3E-D572FA6160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23716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76048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760480" y="291384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CFC62-334F-4A8F-AA8D-5959676628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000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760480" y="1176480"/>
            <a:ext cx="23716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0000" y="2913840"/>
            <a:ext cx="486072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37305-7C62-4A16-8947-34F4BF6F2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0000" y="201240"/>
            <a:ext cx="486072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0000" y="1176480"/>
            <a:ext cx="486072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marL="223920" indent="-2239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84200" indent="-1857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746280" indent="-1494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044720" indent="-14940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34316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34316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343160" indent="-1494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9640" y="4589640"/>
            <a:ext cx="1260360" cy="35064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44640" y="4589640"/>
            <a:ext cx="1711440" cy="35064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870000" y="4589640"/>
            <a:ext cx="1260360" cy="35064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Autofit/>
          </a:bodyPr>
          <a:lstStyle>
            <a:lvl1pPr indent="0" algn="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fld id="{D8B8B2D4-6250-4E76-B846-DC0A06813DA4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-736920" y="897480"/>
            <a:ext cx="1969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hibition of E2F regulator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orter gene activity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04880" y="149400"/>
            <a:ext cx="4600440" cy="175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04880" y="149400"/>
            <a:ext cx="4600440" cy="1752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52400" y="482760"/>
            <a:ext cx="57240" cy="1123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905040" y="635040"/>
            <a:ext cx="56880" cy="9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57320" y="892080"/>
            <a:ext cx="57240" cy="714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09600" y="777960"/>
            <a:ext cx="57240" cy="828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362240" y="996840"/>
            <a:ext cx="66600" cy="609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23880" y="701640"/>
            <a:ext cx="57240" cy="905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676520" y="1054080"/>
            <a:ext cx="56880" cy="552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828800" y="939960"/>
            <a:ext cx="57240" cy="666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981080" y="996840"/>
            <a:ext cx="57240" cy="609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133720" y="825480"/>
            <a:ext cx="56880" cy="781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86000" y="749160"/>
            <a:ext cx="57240" cy="8575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438280" y="825480"/>
            <a:ext cx="57240" cy="781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90920" y="835200"/>
            <a:ext cx="56880" cy="7714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743200" y="892080"/>
            <a:ext cx="57240" cy="714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895480" y="501480"/>
            <a:ext cx="66960" cy="1105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057480" y="615960"/>
            <a:ext cx="57240" cy="99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209760" y="1558800"/>
            <a:ext cx="57240" cy="478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62400" y="1549440"/>
            <a:ext cx="57240" cy="572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14680" y="1606680"/>
            <a:ext cx="57240" cy="378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666960" y="1539720"/>
            <a:ext cx="57240" cy="669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819600" y="1606680"/>
            <a:ext cx="57240" cy="759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971880" y="1473120"/>
            <a:ext cx="57240" cy="1335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124160" y="1587600"/>
            <a:ext cx="57240" cy="19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276800" y="1558800"/>
            <a:ext cx="57240" cy="478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429080" y="1606680"/>
            <a:ext cx="66600" cy="19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591080" y="1568520"/>
            <a:ext cx="57240" cy="381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743360" y="1606680"/>
            <a:ext cx="57240" cy="950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896000" y="1606680"/>
            <a:ext cx="56880" cy="1141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048280" y="1521000"/>
            <a:ext cx="57240" cy="856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200560" y="1606680"/>
            <a:ext cx="57240" cy="171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04880" y="190188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04880" y="160668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04880" y="132084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04880" y="102564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04880" y="730080"/>
            <a:ext cx="47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04880" y="44460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04880" y="149400"/>
            <a:ext cx="47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04880" y="1606680"/>
            <a:ext cx="46004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7048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85716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100980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11620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131436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14763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16286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17812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19335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20858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22384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23907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25430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26956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28479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30099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31622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33148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34671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36194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37720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39243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407664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422928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43815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45435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469584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484812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500076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5153040" y="15685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5305320" y="15685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94640" y="1835280"/>
            <a:ext cx="16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96160" y="1539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32440" y="12542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32440" y="95868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532440" y="66348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32440" y="3780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68720" y="824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rot="16200000">
            <a:off x="687240" y="197784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6200000">
            <a:off x="757440" y="2066040"/>
            <a:ext cx="340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-2 O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rot="16200000">
            <a:off x="914400" y="2057760"/>
            <a:ext cx="33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F-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6200000">
            <a:off x="1087560" y="2046600"/>
            <a:ext cx="29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LD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rot="16200000">
            <a:off x="1182600" y="2076120"/>
            <a:ext cx="40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CT 1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rot="16200000">
            <a:off x="1387440" y="2028240"/>
            <a:ext cx="322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pG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rot="16200000">
            <a:off x="1474920" y="210312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rot="16200000">
            <a:off x="1734120" y="2000160"/>
            <a:ext cx="23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5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rot="16200000">
            <a:off x="1788120" y="2104200"/>
            <a:ext cx="43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ACC-6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rot="16200000">
            <a:off x="1877760" y="214920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H-27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16200000">
            <a:off x="2123640" y="2079360"/>
            <a:ext cx="374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ANC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rot="16200000">
            <a:off x="2250000" y="2067120"/>
            <a:ext cx="42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U.86.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200000">
            <a:off x="2417400" y="208116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N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6200000">
            <a:off x="2574720" y="206676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s 746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6200000">
            <a:off x="2722320" y="207108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KATO I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16200000">
            <a:off x="2901240" y="2072160"/>
            <a:ext cx="36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CC-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rot="16200000">
            <a:off x="3151800" y="1977120"/>
            <a:ext cx="16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J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6200000">
            <a:off x="3188160" y="2070360"/>
            <a:ext cx="39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La S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6200000">
            <a:off x="3366720" y="2047320"/>
            <a:ext cx="34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U 1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6200000">
            <a:off x="3481560" y="2082600"/>
            <a:ext cx="419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CCSU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6200000">
            <a:off x="3534840" y="2173680"/>
            <a:ext cx="61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-MB-4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6200000">
            <a:off x="3687480" y="2173680"/>
            <a:ext cx="61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-MB-4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6200000">
            <a:off x="3981600" y="2057760"/>
            <a:ext cx="33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F-5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6200000">
            <a:off x="4179600" y="2002320"/>
            <a:ext cx="24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L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6200000">
            <a:off x="4291560" y="2062800"/>
            <a:ext cx="31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-33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6200000">
            <a:off x="4457160" y="2052360"/>
            <a:ext cx="316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u-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6200000">
            <a:off x="4542120" y="210312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6200000">
            <a:off x="4665960" y="2125440"/>
            <a:ext cx="50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14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16200000">
            <a:off x="4874760" y="208116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rot="16200000">
            <a:off x="4999320" y="210312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5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733320" y="2604960"/>
            <a:ext cx="4572000" cy="176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733320" y="2604960"/>
            <a:ext cx="4572000" cy="1762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781200" y="3119400"/>
            <a:ext cx="568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933480" y="3195720"/>
            <a:ext cx="57240" cy="247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085760" y="3195720"/>
            <a:ext cx="57240" cy="142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238400" y="3195720"/>
            <a:ext cx="56880" cy="572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390680" y="3195720"/>
            <a:ext cx="57240" cy="180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542960" y="3195720"/>
            <a:ext cx="5724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695600" y="3195720"/>
            <a:ext cx="56880" cy="218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847880" y="3195720"/>
            <a:ext cx="57240" cy="218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000160" y="3195720"/>
            <a:ext cx="57240" cy="304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152800" y="3195720"/>
            <a:ext cx="56880" cy="237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305080" y="3195720"/>
            <a:ext cx="57240" cy="237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457360" y="3195720"/>
            <a:ext cx="5724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610000" y="3195720"/>
            <a:ext cx="56880" cy="162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762280" y="3195720"/>
            <a:ext cx="57240" cy="162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914560" y="3186000"/>
            <a:ext cx="57240" cy="9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067200" y="3195720"/>
            <a:ext cx="56880" cy="171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219480" y="3195720"/>
            <a:ext cx="57240" cy="1047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524400" y="3195720"/>
            <a:ext cx="56880" cy="190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676680" y="3195720"/>
            <a:ext cx="57240" cy="1076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828960" y="3195720"/>
            <a:ext cx="57240" cy="7239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981600" y="3195720"/>
            <a:ext cx="56880" cy="1076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4133880" y="3195720"/>
            <a:ext cx="57240" cy="590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286160" y="3195720"/>
            <a:ext cx="57240" cy="190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438800" y="3195720"/>
            <a:ext cx="56880" cy="2952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591080" y="3195720"/>
            <a:ext cx="57240" cy="7142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4743360" y="3195720"/>
            <a:ext cx="57240" cy="495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896000" y="3195720"/>
            <a:ext cx="56880" cy="514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048280" y="3195720"/>
            <a:ext cx="57240" cy="495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200560" y="3195720"/>
            <a:ext cx="57240" cy="6192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733320" y="4367160"/>
            <a:ext cx="47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33320" y="4071960"/>
            <a:ext cx="47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733320" y="3776760"/>
            <a:ext cx="47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733320" y="3490920"/>
            <a:ext cx="47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733320" y="3195720"/>
            <a:ext cx="47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733320" y="2900520"/>
            <a:ext cx="47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733320" y="3195720"/>
            <a:ext cx="4572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7333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flipV="1">
            <a:off x="8859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10382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V="1">
            <a:off x="11905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13431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14954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16477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V="1">
            <a:off x="18003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19526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V="1">
            <a:off x="21049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22575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24098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25621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flipV="1">
            <a:off x="27147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flipV="1">
            <a:off x="28670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30193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31719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flipV="1">
            <a:off x="33242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 flipV="1">
            <a:off x="34765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36291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37814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39337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V="1">
            <a:off x="40863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42386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flipV="1">
            <a:off x="43909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45435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46958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flipV="1">
            <a:off x="48481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V="1">
            <a:off x="500076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5153040" y="315756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flipV="1">
            <a:off x="5305320" y="315756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558000" y="4300560"/>
            <a:ext cx="102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462600" y="4005360"/>
            <a:ext cx="198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1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558000" y="3710160"/>
            <a:ext cx="102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62600" y="3424320"/>
            <a:ext cx="198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96160" y="31291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500400" y="283356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596160" y="25542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rot="16200000">
            <a:off x="716040" y="441504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 rot="16200000">
            <a:off x="785880" y="4515480"/>
            <a:ext cx="340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-2 O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 rot="16200000">
            <a:off x="941400" y="4507200"/>
            <a:ext cx="33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F-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rot="16200000">
            <a:off x="1114560" y="4497120"/>
            <a:ext cx="29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LD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 rot="16200000">
            <a:off x="1209600" y="4527360"/>
            <a:ext cx="40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CT 1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rot="16200000">
            <a:off x="1404720" y="4479480"/>
            <a:ext cx="322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pG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rot="16200000">
            <a:off x="1492560" y="455436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 rot="16200000">
            <a:off x="1751400" y="4451400"/>
            <a:ext cx="23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5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 rot="16200000">
            <a:off x="1807200" y="4553640"/>
            <a:ext cx="43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UACC-6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 rot="16200000">
            <a:off x="1896840" y="461484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H-27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 rot="16200000">
            <a:off x="2142360" y="4529160"/>
            <a:ext cx="374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ANC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 rot="16200000">
            <a:off x="2269080" y="4529520"/>
            <a:ext cx="42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U.86.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 rot="16200000">
            <a:off x="2436480" y="453060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N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rot="16200000">
            <a:off x="2593440" y="451620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s 746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rot="16200000">
            <a:off x="2741400" y="452052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KATO I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rot="16200000">
            <a:off x="2910600" y="4522320"/>
            <a:ext cx="36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CC-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rot="16200000">
            <a:off x="3161160" y="4426560"/>
            <a:ext cx="16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J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rot="16200000">
            <a:off x="3197880" y="4517640"/>
            <a:ext cx="39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La S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rot="16200000">
            <a:off x="3376080" y="4495320"/>
            <a:ext cx="34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U 1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rot="16200000">
            <a:off x="3490920" y="4530600"/>
            <a:ext cx="419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CCSU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rot="16200000">
            <a:off x="3544560" y="4637520"/>
            <a:ext cx="61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-MB-4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rot="16200000">
            <a:off x="3695400" y="4637520"/>
            <a:ext cx="61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DA-MB-4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rot="16200000">
            <a:off x="3989520" y="4505040"/>
            <a:ext cx="33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F-5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rot="16200000">
            <a:off x="4187520" y="4450320"/>
            <a:ext cx="24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eL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rot="16200000">
            <a:off x="4302720" y="4512240"/>
            <a:ext cx="31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-33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rot="16200000">
            <a:off x="4457160" y="4502160"/>
            <a:ext cx="316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u-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rot="16200000">
            <a:off x="4542120" y="455256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rot="16200000">
            <a:off x="4665960" y="4574880"/>
            <a:ext cx="50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14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rot="16200000">
            <a:off x="4874760" y="4530600"/>
            <a:ext cx="39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rot="16200000">
            <a:off x="4999320" y="4552560"/>
            <a:ext cx="45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CI-H5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 rot="16200000">
            <a:off x="-708480" y="3351600"/>
            <a:ext cx="19702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lative RB1 mR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42560" y="64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42560" y="24750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596880"/>
                <a:tab algn="l" pos="1193760"/>
                <a:tab algn="l" pos="1790640"/>
                <a:tab algn="l" pos="2387520"/>
                <a:tab algn="l" pos="2984400"/>
                <a:tab algn="l" pos="3581280"/>
                <a:tab algn="l" pos="4178160"/>
                <a:tab algn="l" pos="4775040"/>
                <a:tab algn="l" pos="5372280"/>
                <a:tab algn="l" pos="5969160"/>
                <a:tab algn="l" pos="6566040"/>
                <a:tab algn="l" pos="7162920"/>
                <a:tab algn="l" pos="7759800"/>
                <a:tab algn="l" pos="8356680"/>
                <a:tab algn="l" pos="8953560"/>
                <a:tab algn="l" pos="9550440"/>
                <a:tab algn="l" pos="10147320"/>
                <a:tab algn="l" pos="10744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1:37:15Z</dcterms:created>
  <dc:creator>Merck</dc:creator>
  <dc:description/>
  <dc:language>en-US</dc:language>
  <cp:lastModifiedBy>X40312</cp:lastModifiedBy>
  <dcterms:modified xsi:type="dcterms:W3CDTF">2011-03-04T03:40:14Z</dcterms:modified>
  <cp:revision>87</cp:revision>
  <dc:subject/>
  <dc:title>スライド 1</dc:title>
</cp:coreProperties>
</file>